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8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2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B7A19-2EB7-506C-0C6D-856B4AC687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74C8DC-C52D-B195-D8BB-06164894D3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E3E31B-A5ED-1376-A107-05978D6C1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708F22-43F9-AE8C-A167-1F0F08006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E7AEC6-0570-A075-38BA-FBEE76337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10957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6F9FE1-849F-EB9E-B607-A13BE1FDE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61903A-4B5A-C929-3934-E3B4C1555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3FD206-769C-1EE6-1DBD-AE61C40E3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BDD5E-7B92-19D8-2D6B-10A389B88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FDE23A-6F1D-4EC5-B86A-F29E4A652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13282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4C6F3A-0D53-B8F5-FB15-0B94BB26BC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9525D5-58B1-32FE-8EDA-5A5CDC7F3C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4C5770-CD29-D99D-D776-FFBD22E21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3EC9E3-080B-D887-E704-CCFDDE429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552273-4239-930D-3848-1D08502DE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90193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A604C0-9C65-F7A7-9BFF-72EF278862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A305B9-5277-6F5B-F464-E8895E7BE2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BF083E-763C-D5A3-3D97-F9B2ECE34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08CABA-889F-88A4-B7A0-202FD31E6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FC65CB-676D-1B5E-3438-0A203777E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90901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45D31E-63AF-ABC0-5B27-3070EFD899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3C61A5-EC84-1F81-1DE8-392ECB20D0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09D02B-48AB-8D0B-143B-E4786B644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8FE693-18E6-6BED-EF95-D319720A0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019287-2E88-40F5-DCD3-492FC5789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35970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E17F17-2CD8-E0FF-BE69-C4081DEB3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301EC-398A-E660-1F38-0AEBEA9136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E41260-2FD4-54B5-2AF7-39C7B03482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DE7C9D-87A9-C450-2144-3834128E1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5EDF97-FE39-9E95-6C28-2586A010F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23E766-AEA6-6E5E-F66E-EDCDAD84A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19756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F2331-25CE-7E2F-2ABB-0B0E674EA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716260-9A6A-40D8-EE7E-68A40DC682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A7507C-B70F-2E4D-A97B-A5F10414C2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70C0F0-34A6-2A59-39B4-B561C34B62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E932AD-BB2B-D77F-C906-8D867A8DEF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AFEE3D-D843-2200-CDE6-C8D1DAA06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CC63E0-7401-ECCD-0A8C-CF57BFD292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ED21C7-B873-B65F-2E31-EEDF436C5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50032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A5DB5-C2A1-1BC9-5C6C-6DD4DC4B9A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37211AC-6834-7FE5-6B6B-3C5F63A11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25B1D1-D071-1D6E-CE91-ED074479D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F8056F-412E-116B-3E5C-16D4ACE22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55792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D12679-7D21-F514-6631-2C18BD368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CA543E-0917-2F52-371D-651B10605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A3F19E-8C95-6C09-6205-98637DE91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10230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8A88A-EA37-C557-1150-796A13784D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81909-3892-3A5F-B24F-B4E5EB920E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5243D7-B01D-10D8-3CC3-481014D2A1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C3D7EB-32EF-BF64-5E3B-386E2EB63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9D9872-C3B6-2D76-7B5A-B91E1FAA7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0420BE-D781-6986-21F5-E8B37170E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35581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736BF-3C5D-4D01-3EDE-CCD179B916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F9E292-CF71-638C-9911-F3478218D2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4C8296-F0E4-834F-B486-F64BC7FB3B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AE5C45-7A24-AA22-9FEA-8FCD2B557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590513-BBED-6598-FC3B-5E9E533D8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902AAE-E750-16FB-1E7D-07F63AF93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53777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382C2C-D89F-2F2A-7430-AAE85AFA3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EB2A2D-7435-A0A7-79EB-E3A1B80753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2429F1-BD39-B45E-6D83-99F0ADFC57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CEAF38-DBFB-460F-8F7F-1404917DE23F}" type="datetimeFigureOut">
              <a:rPr lang="en-IE" smtClean="0"/>
              <a:t>01/07/2024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A6F5AB-34CB-E83F-A18E-9F91DC1A61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4F94FD-6E09-C845-0093-7F06405D4C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16DBD3-E55C-4332-9507-175C93FBE678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44223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6">
            <a:extLst>
              <a:ext uri="{FF2B5EF4-FFF2-40B4-BE49-F238E27FC236}">
                <a16:creationId xmlns:a16="http://schemas.microsoft.com/office/drawing/2014/main" id="{8A0759A6-A8D7-3F61-D2AC-317AC135CFB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99603" y="292051"/>
            <a:ext cx="5096397" cy="2856079"/>
          </a:xfrm>
          <a:ln w="6350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36AFE46-6AF0-6675-DFFC-3D105D2FEB2A}"/>
              </a:ext>
            </a:extLst>
          </p:cNvPr>
          <p:cNvSpPr txBox="1"/>
          <p:nvPr/>
        </p:nvSpPr>
        <p:spPr>
          <a:xfrm>
            <a:off x="392038" y="150338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9A21E7B-EC13-6242-963D-BD15EDF9B32C}"/>
              </a:ext>
            </a:extLst>
          </p:cNvPr>
          <p:cNvSpPr txBox="1"/>
          <p:nvPr/>
        </p:nvSpPr>
        <p:spPr>
          <a:xfrm>
            <a:off x="641255" y="527928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A.i</a:t>
            </a:r>
            <a:endParaRPr lang="en-IE" sz="9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58B0CF-159A-4324-7CD7-86B9512BC707}"/>
              </a:ext>
            </a:extLst>
          </p:cNvPr>
          <p:cNvSpPr txBox="1"/>
          <p:nvPr/>
        </p:nvSpPr>
        <p:spPr>
          <a:xfrm>
            <a:off x="641255" y="1188420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A.ii</a:t>
            </a:r>
            <a:endParaRPr lang="en-IE" sz="9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0E6E59-9329-F286-950F-B3C51C4ABA19}"/>
              </a:ext>
            </a:extLst>
          </p:cNvPr>
          <p:cNvSpPr txBox="1"/>
          <p:nvPr/>
        </p:nvSpPr>
        <p:spPr>
          <a:xfrm>
            <a:off x="641255" y="1828796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A.iii</a:t>
            </a:r>
            <a:endParaRPr lang="en-IE" sz="9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64F1BE-0715-CB34-C0E8-3453C22F58BB}"/>
              </a:ext>
            </a:extLst>
          </p:cNvPr>
          <p:cNvSpPr txBox="1"/>
          <p:nvPr/>
        </p:nvSpPr>
        <p:spPr>
          <a:xfrm>
            <a:off x="641255" y="2490355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A.iv</a:t>
            </a:r>
            <a:endParaRPr lang="en-IE" sz="900" b="1" dirty="0"/>
          </a:p>
        </p:txBody>
      </p:sp>
      <p:pic>
        <p:nvPicPr>
          <p:cNvPr id="10" name="Content Placeholder 6">
            <a:extLst>
              <a:ext uri="{FF2B5EF4-FFF2-40B4-BE49-F238E27FC236}">
                <a16:creationId xmlns:a16="http://schemas.microsoft.com/office/drawing/2014/main" id="{512C4532-6134-E4BE-99EE-8C788256FF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5317" y="3248964"/>
            <a:ext cx="5096398" cy="285607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A7F2E299-462E-843A-7716-B5DBD5B1B461}"/>
              </a:ext>
            </a:extLst>
          </p:cNvPr>
          <p:cNvSpPr txBox="1"/>
          <p:nvPr/>
        </p:nvSpPr>
        <p:spPr>
          <a:xfrm>
            <a:off x="222355" y="3173674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B)</a:t>
            </a:r>
            <a:endParaRPr lang="en-IE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19B7905-4D96-2256-A4B1-7A6FDC2584E5}"/>
              </a:ext>
            </a:extLst>
          </p:cNvPr>
          <p:cNvSpPr txBox="1"/>
          <p:nvPr/>
        </p:nvSpPr>
        <p:spPr>
          <a:xfrm>
            <a:off x="607207" y="3406636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B.i</a:t>
            </a:r>
            <a:endParaRPr lang="en-IE" sz="9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DD8F43B-F2A4-F39E-685B-3B58257B3B0B}"/>
              </a:ext>
            </a:extLst>
          </p:cNvPr>
          <p:cNvSpPr txBox="1"/>
          <p:nvPr/>
        </p:nvSpPr>
        <p:spPr>
          <a:xfrm>
            <a:off x="607207" y="3792744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B.ii</a:t>
            </a:r>
            <a:endParaRPr lang="en-IE" sz="900" b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115EF3F-16A2-C208-4C3C-8E499A175556}"/>
              </a:ext>
            </a:extLst>
          </p:cNvPr>
          <p:cNvSpPr txBox="1"/>
          <p:nvPr/>
        </p:nvSpPr>
        <p:spPr>
          <a:xfrm>
            <a:off x="607207" y="4500781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B.iv</a:t>
            </a:r>
            <a:endParaRPr lang="en-IE" sz="9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48B0656-B53D-902F-613F-597F40D48A94}"/>
              </a:ext>
            </a:extLst>
          </p:cNvPr>
          <p:cNvSpPr txBox="1"/>
          <p:nvPr/>
        </p:nvSpPr>
        <p:spPr>
          <a:xfrm>
            <a:off x="607207" y="4105191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B.iii</a:t>
            </a:r>
            <a:endParaRPr lang="en-IE" sz="9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1F4194A-CD3C-C18A-D18F-1CAC72EB451F}"/>
              </a:ext>
            </a:extLst>
          </p:cNvPr>
          <p:cNvSpPr txBox="1"/>
          <p:nvPr/>
        </p:nvSpPr>
        <p:spPr>
          <a:xfrm>
            <a:off x="607207" y="4892715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B.v</a:t>
            </a:r>
            <a:endParaRPr lang="en-IE" sz="9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C6F0A07-FF5F-6C4D-BFC0-37203E4AEBE2}"/>
              </a:ext>
            </a:extLst>
          </p:cNvPr>
          <p:cNvSpPr txBox="1"/>
          <p:nvPr/>
        </p:nvSpPr>
        <p:spPr>
          <a:xfrm>
            <a:off x="607207" y="5268047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/>
              <a:t>B.vi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CFCF401-6BF1-E38F-94B6-8244C7C6DF31}"/>
              </a:ext>
            </a:extLst>
          </p:cNvPr>
          <p:cNvSpPr txBox="1"/>
          <p:nvPr/>
        </p:nvSpPr>
        <p:spPr>
          <a:xfrm>
            <a:off x="607207" y="5643379"/>
            <a:ext cx="508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900" b="1" dirty="0" err="1"/>
              <a:t>B.vii</a:t>
            </a:r>
            <a:endParaRPr lang="en-IE" sz="9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D3BE8DE-0662-4CC0-9529-ECBF7132A74E}"/>
              </a:ext>
            </a:extLst>
          </p:cNvPr>
          <p:cNvSpPr txBox="1"/>
          <p:nvPr/>
        </p:nvSpPr>
        <p:spPr>
          <a:xfrm>
            <a:off x="5022629" y="4411503"/>
            <a:ext cx="5677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Maltos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66037AF-66BA-6359-0621-1AF6FDD740AF}"/>
              </a:ext>
            </a:extLst>
          </p:cNvPr>
          <p:cNvSpPr txBox="1"/>
          <p:nvPr/>
        </p:nvSpPr>
        <p:spPr>
          <a:xfrm>
            <a:off x="2308819" y="4411503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Glucose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C30CB9B6-63E5-C155-7FD1-70209A9952A8}"/>
              </a:ext>
            </a:extLst>
          </p:cNvPr>
          <p:cNvCxnSpPr>
            <a:cxnSpLocks/>
          </p:cNvCxnSpPr>
          <p:nvPr/>
        </p:nvCxnSpPr>
        <p:spPr>
          <a:xfrm flipH="1">
            <a:off x="2182719" y="4516745"/>
            <a:ext cx="126100" cy="100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388DC858-557C-094E-9D05-6F58845BAC1C}"/>
              </a:ext>
            </a:extLst>
          </p:cNvPr>
          <p:cNvCxnSpPr>
            <a:cxnSpLocks/>
          </p:cNvCxnSpPr>
          <p:nvPr/>
        </p:nvCxnSpPr>
        <p:spPr>
          <a:xfrm flipH="1">
            <a:off x="4907721" y="4506447"/>
            <a:ext cx="142204" cy="901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58CC9AC-9E60-D7E4-3DA2-F2284D678D0D}"/>
              </a:ext>
            </a:extLst>
          </p:cNvPr>
          <p:cNvSpPr txBox="1"/>
          <p:nvPr/>
        </p:nvSpPr>
        <p:spPr>
          <a:xfrm>
            <a:off x="4978658" y="5159455"/>
            <a:ext cx="5677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Maltos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F7CB201-EA1A-B021-F0C0-8EE83DC5B6B2}"/>
              </a:ext>
            </a:extLst>
          </p:cNvPr>
          <p:cNvSpPr txBox="1"/>
          <p:nvPr/>
        </p:nvSpPr>
        <p:spPr>
          <a:xfrm>
            <a:off x="2346736" y="515263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Glucose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7C502343-3BE1-4159-33B7-E7A4DAC42630}"/>
              </a:ext>
            </a:extLst>
          </p:cNvPr>
          <p:cNvCxnSpPr>
            <a:cxnSpLocks/>
          </p:cNvCxnSpPr>
          <p:nvPr/>
        </p:nvCxnSpPr>
        <p:spPr>
          <a:xfrm flipH="1">
            <a:off x="2220636" y="5257873"/>
            <a:ext cx="126100" cy="100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C82FB0AF-D0D9-7B19-EE79-20F33E5736CF}"/>
              </a:ext>
            </a:extLst>
          </p:cNvPr>
          <p:cNvSpPr txBox="1"/>
          <p:nvPr/>
        </p:nvSpPr>
        <p:spPr>
          <a:xfrm>
            <a:off x="4990309" y="3291220"/>
            <a:ext cx="5677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Maltos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E83FCCC-0751-555A-7E38-2FAD89349803}"/>
              </a:ext>
            </a:extLst>
          </p:cNvPr>
          <p:cNvSpPr txBox="1"/>
          <p:nvPr/>
        </p:nvSpPr>
        <p:spPr>
          <a:xfrm>
            <a:off x="2276499" y="329122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Glucose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A5D56B7E-B2DB-730A-5803-130F94720BB2}"/>
              </a:ext>
            </a:extLst>
          </p:cNvPr>
          <p:cNvCxnSpPr>
            <a:cxnSpLocks/>
          </p:cNvCxnSpPr>
          <p:nvPr/>
        </p:nvCxnSpPr>
        <p:spPr>
          <a:xfrm flipH="1">
            <a:off x="2150399" y="3396462"/>
            <a:ext cx="126100" cy="100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1A39593-43CF-0A3F-24A1-1DBD85CC5069}"/>
              </a:ext>
            </a:extLst>
          </p:cNvPr>
          <p:cNvCxnSpPr>
            <a:cxnSpLocks/>
          </p:cNvCxnSpPr>
          <p:nvPr/>
        </p:nvCxnSpPr>
        <p:spPr>
          <a:xfrm flipH="1">
            <a:off x="4868577" y="3399812"/>
            <a:ext cx="142204" cy="901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D3EE946-F924-8CA8-D4FF-41AF76D3D786}"/>
              </a:ext>
            </a:extLst>
          </p:cNvPr>
          <p:cNvSpPr txBox="1"/>
          <p:nvPr/>
        </p:nvSpPr>
        <p:spPr>
          <a:xfrm>
            <a:off x="4985283" y="4043872"/>
            <a:ext cx="5677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Maltos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A8783A9-6230-CF7F-4B0A-4B259C52B10D}"/>
              </a:ext>
            </a:extLst>
          </p:cNvPr>
          <p:cNvSpPr txBox="1"/>
          <p:nvPr/>
        </p:nvSpPr>
        <p:spPr>
          <a:xfrm>
            <a:off x="2271473" y="404387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Glucose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EFB4458D-B8D9-F1FE-B15A-EDC6BDE70F7F}"/>
              </a:ext>
            </a:extLst>
          </p:cNvPr>
          <p:cNvCxnSpPr>
            <a:cxnSpLocks/>
          </p:cNvCxnSpPr>
          <p:nvPr/>
        </p:nvCxnSpPr>
        <p:spPr>
          <a:xfrm flipH="1">
            <a:off x="2145373" y="4149114"/>
            <a:ext cx="126100" cy="1002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E49F72CC-304E-A5CC-7DB0-CC2002952805}"/>
              </a:ext>
            </a:extLst>
          </p:cNvPr>
          <p:cNvCxnSpPr>
            <a:cxnSpLocks/>
          </p:cNvCxnSpPr>
          <p:nvPr/>
        </p:nvCxnSpPr>
        <p:spPr>
          <a:xfrm flipH="1">
            <a:off x="4863551" y="4152464"/>
            <a:ext cx="142204" cy="901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98337841-2ECF-8FE7-E6B2-B3465824F09F}"/>
              </a:ext>
            </a:extLst>
          </p:cNvPr>
          <p:cNvSpPr txBox="1"/>
          <p:nvPr/>
        </p:nvSpPr>
        <p:spPr>
          <a:xfrm>
            <a:off x="5049925" y="4791824"/>
            <a:ext cx="5677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Maltose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1F3DA3DE-39B6-BE3F-924D-B1164D85DFC9}"/>
              </a:ext>
            </a:extLst>
          </p:cNvPr>
          <p:cNvCxnSpPr>
            <a:cxnSpLocks/>
          </p:cNvCxnSpPr>
          <p:nvPr/>
        </p:nvCxnSpPr>
        <p:spPr>
          <a:xfrm flipH="1">
            <a:off x="4928193" y="4900416"/>
            <a:ext cx="142204" cy="901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2C1D6067-57B7-9DCE-2A3C-CAA9E25594DA}"/>
              </a:ext>
            </a:extLst>
          </p:cNvPr>
          <p:cNvSpPr txBox="1"/>
          <p:nvPr/>
        </p:nvSpPr>
        <p:spPr>
          <a:xfrm>
            <a:off x="6487885" y="150338"/>
            <a:ext cx="463319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E" sz="1400" b="1" dirty="0"/>
              <a:t>Supplementary Figure 1: 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HPAEC-PAD chromatograms profiles after 24h incubation at 37C incubated with different substrates. Panel (A) Pullulan (Ai)with the product of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Aii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Amy1</a:t>
            </a:r>
            <a:r>
              <a:rPr lang="en-GB" sz="1400" baseline="-250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His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,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Aiii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Amy2</a:t>
            </a:r>
            <a:r>
              <a:rPr lang="en-GB" sz="1400" baseline="-250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His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 and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Aiv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Amy3</a:t>
            </a:r>
            <a:r>
              <a:rPr lang="en-GB" sz="1400" baseline="-250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His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. (B) The product of Amy3</a:t>
            </a:r>
            <a:r>
              <a:rPr lang="en-GB" sz="1400" baseline="-250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His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 incubated with starch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B.i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,  amylopectin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B.ii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, amylose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B.iii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, maltodextrin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B.iv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, maltose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B.v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, glycogen (B.vi) and pullulan (</a:t>
            </a:r>
            <a:r>
              <a:rPr lang="en-GB" sz="1400" dirty="0" err="1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B.vii</a:t>
            </a:r>
            <a:r>
              <a:rPr lang="en-GB" sz="1400" dirty="0">
                <a:effectLst/>
                <a:ea typeface="Times" panose="02020603050405020304" pitchFamily="18" charset="0"/>
                <a:cs typeface="Times New Roman" panose="02020603050405020304" pitchFamily="18" charset="0"/>
              </a:rPr>
              <a:t>). </a:t>
            </a:r>
            <a:endParaRPr lang="en-IE" sz="1400" dirty="0"/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D3BC920B-B4B7-9C41-B748-BA7E9F7E8CA5}"/>
              </a:ext>
            </a:extLst>
          </p:cNvPr>
          <p:cNvCxnSpPr>
            <a:cxnSpLocks/>
          </p:cNvCxnSpPr>
          <p:nvPr/>
        </p:nvCxnSpPr>
        <p:spPr>
          <a:xfrm flipH="1">
            <a:off x="4878002" y="5264143"/>
            <a:ext cx="142204" cy="901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3807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2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cio Sanchez Gallardo (Umail)</dc:creator>
  <cp:lastModifiedBy>Rocio Sanchez Gallardo (Umail)</cp:lastModifiedBy>
  <cp:revision>1</cp:revision>
  <dcterms:created xsi:type="dcterms:W3CDTF">2024-07-01T22:37:26Z</dcterms:created>
  <dcterms:modified xsi:type="dcterms:W3CDTF">2024-07-01T22:38:29Z</dcterms:modified>
</cp:coreProperties>
</file>